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A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10" autoAdjust="0"/>
    <p:restoredTop sz="94660"/>
  </p:normalViewPr>
  <p:slideViewPr>
    <p:cSldViewPr snapToGrid="0">
      <p:cViewPr varScale="1">
        <p:scale>
          <a:sx n="78" d="100"/>
          <a:sy n="78" d="100"/>
        </p:scale>
        <p:origin x="296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71D091-5963-4814-B792-8F940D9FD478}" type="datetimeFigureOut">
              <a:rPr lang="en-US" smtClean="0"/>
              <a:t>7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4DFD68-0589-4712-8F7A-B662EDE18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262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1044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622508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747171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32486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46142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04416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32848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629644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037469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538952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97950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37902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7F8B14A-BBA4-44E5-A6A0-F99B69268FD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5000"/>
          <a:stretch/>
        </p:blipFill>
        <p:spPr>
          <a:xfrm>
            <a:off x="1059609" y="1563240"/>
            <a:ext cx="4908800" cy="177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2BD985C-CAD3-4B39-BD81-2A46741ACF4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5000"/>
          <a:stretch/>
        </p:blipFill>
        <p:spPr>
          <a:xfrm>
            <a:off x="1059609" y="3339240"/>
            <a:ext cx="4908800" cy="1776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B50EFF8-4E4F-45CB-B319-2BA8241BE75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507" b="-1"/>
          <a:stretch/>
        </p:blipFill>
        <p:spPr>
          <a:xfrm>
            <a:off x="1059609" y="6927856"/>
            <a:ext cx="4908800" cy="181112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432E5A8-0980-4099-A34C-D73C3EB2B81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679" b="25498"/>
          <a:stretch/>
        </p:blipFill>
        <p:spPr>
          <a:xfrm>
            <a:off x="1059609" y="5139824"/>
            <a:ext cx="4908800" cy="176344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1134978-C339-46FF-ACED-91305F678B0B}"/>
              </a:ext>
            </a:extLst>
          </p:cNvPr>
          <p:cNvSpPr txBox="1"/>
          <p:nvPr/>
        </p:nvSpPr>
        <p:spPr>
          <a:xfrm>
            <a:off x="492830" y="432000"/>
            <a:ext cx="619457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/>
              <a:t>S6 FIGURE </a:t>
            </a:r>
            <a:r>
              <a:rPr lang="en-US" sz="1100" b="1" dirty="0"/>
              <a:t>6 | </a:t>
            </a:r>
            <a:r>
              <a:rPr lang="en-US" sz="1100" dirty="0"/>
              <a:t>PRM data of a representative clinical specimen of COVID-19 patient cohort 2. Fragment ion chromatograms for various SARS-CoV-2 target peptides in one representative clinical specimen. The upper panels show the spiked-in AQUA peptide signals; if no AQUA peptide counterpart was available upper panels are left empty. </a:t>
            </a:r>
            <a:endParaRPr lang="en-US" sz="1100" i="1" dirty="0"/>
          </a:p>
        </p:txBody>
      </p:sp>
    </p:spTree>
    <p:extLst>
      <p:ext uri="{BB962C8B-B14F-4D97-AF65-F5344CB8AC3E}">
        <p14:creationId xmlns:p14="http://schemas.microsoft.com/office/powerpoint/2010/main" val="3286050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1</TotalTime>
  <Words>54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oen Demmers</dc:creator>
  <cp:lastModifiedBy>J.A.A. Demmers</cp:lastModifiedBy>
  <cp:revision>444</cp:revision>
  <dcterms:created xsi:type="dcterms:W3CDTF">2020-04-19T12:14:45Z</dcterms:created>
  <dcterms:modified xsi:type="dcterms:W3CDTF">2021-07-15T09:36:57Z</dcterms:modified>
</cp:coreProperties>
</file>